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0" r:id="rId2"/>
    <p:sldId id="324" r:id="rId3"/>
    <p:sldId id="300" r:id="rId4"/>
    <p:sldId id="325" r:id="rId5"/>
    <p:sldId id="319" r:id="rId6"/>
    <p:sldId id="313" r:id="rId7"/>
    <p:sldId id="270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17" autoAdjust="0"/>
    <p:restoredTop sz="96233" autoAdjust="0"/>
  </p:normalViewPr>
  <p:slideViewPr>
    <p:cSldViewPr snapToGrid="0">
      <p:cViewPr varScale="1">
        <p:scale>
          <a:sx n="99" d="100"/>
          <a:sy n="99" d="100"/>
        </p:scale>
        <p:origin x="51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6C48D4-EC70-24D5-E043-E99E014008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FC65AD8-5FA7-4D40-2774-FA3B062603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78E284-B710-5436-C758-691D4077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C16CBE-93DD-9334-7398-804E8F724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E08F15-2E3B-8E73-FA96-4D59272E2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5750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054F82-8C95-022E-9EF9-72E26D6DB3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F4974C4-9FD7-99EA-F589-2FD2113B47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1698E2-3B5B-5072-A990-C635D849C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E32264-8B6E-9063-930E-11E15F028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6FB093-9C7C-3853-BFF7-7D1733B83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8831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F52F58D-EDFC-BBFB-AD0C-A9B8DFC2DE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511E044-793D-7E34-FF86-3681FCF60C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67CB2-38C0-D4E3-1CE8-AD522F61B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C88389-F8F9-A409-42D0-5B80FBEAB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F1D605-DDAF-FE83-29F6-24DBEF769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689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F9F709-7C6B-3634-B52B-1E2063F5A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782F53-51AF-0280-1926-18F3BDA017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FF1C32-B689-36BF-83C3-4C691830E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64F7D0-EBE8-6718-186F-A7C014D13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71A6EA-54E0-1C59-ACD6-E13756687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39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285CF3-5703-486F-E667-5C23D3083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127696E-E56E-A6FF-498E-98D42DB227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9DA767-6BAB-BA9C-E7F5-CC8B4313E6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A6F957-051C-E655-DA0B-882F7C2B4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CDD69B-44DE-F403-11DB-5211EDE9A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2528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77C6A3-0CE3-8B26-0A94-0F907100DF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32764C8-9CFD-5F14-9F9F-4CD0302D7F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1F4FF5-8DEE-9FDF-B104-6834871610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DEF30FB-131F-9EC3-EB91-45BDA0B6F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C5CBC39-216A-1EF5-C766-ABCD72655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B26BB0-7A3B-F45E-7258-829E864C2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3835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124601-6FB4-ED71-35DA-DE30269C5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831584-71E6-E886-5665-371A3C9A3F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F0B14B3-3206-152A-F65E-5D51BFA1A6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3C02807-B7EE-9636-5D8A-3DDD20D20F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4587DD7-2A02-89FC-D23B-D06B179F88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2C12967-1D4C-6DAE-F4AF-CB6DE6161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E3679EC-A36B-37EA-1F88-D09E9CBEE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F8C6BFA-0873-E9DB-9262-C00FEE9CD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74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92AE72-3962-91F9-28DD-07A589952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E64E944-1377-4DF4-1B1A-925AD3E4D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E0F5421-4256-0264-E771-3B0E636A3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8D3DC2D-119E-6B1E-950F-31E23D33D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7699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BC034F2-7DBD-D1DF-9BCD-EE25BCEB8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2F78CE2-89CC-D9FF-F08A-CDA6F2175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A65AE98-E1DB-4410-7EAE-FF8C94213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99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E4B681-FEF4-B524-F405-B320AD1C9F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7437448-E5F8-DAF0-BE3F-8778A05AA8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B8F143-893A-1D8F-99A0-1BB0B8736C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E67B5F-2B4E-2727-B059-4F01FAEBE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3F399E6-731E-209B-BDFE-A93A0F241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6CC33A5-8CFF-FE39-6D9E-C2DC6EF04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2832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4152D4-480B-0B2B-507B-B094CD82F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0703520-3151-BA87-B358-10334C9D4E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F4D1F67-7CB3-107F-973B-1577C2CDA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CCB61FF-B0E2-07EF-ADD9-368211858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B4A6C5-A74F-7EFC-B61F-F4606F6B6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B4BC0A8-986A-AC46-850F-5DB76D8F1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831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8F35DF4-A3D3-6F5E-2EEA-E92E85F5D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0ACC3D-DC7A-FAB7-85D8-B66D128348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AD3FFC-89BA-A1D2-9F33-CC20998254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2C31F-D9F1-458B-A3B7-3650865489B6}" type="datetimeFigureOut">
              <a:rPr kumimoji="1" lang="ja-JP" altLang="en-US" smtClean="0"/>
              <a:t>2023/3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6DA4BD-3E90-004C-78DF-4D80E9E457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ED836E-2724-1ED4-69E6-016829A8DA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6BC38-810E-4DD9-B44A-78163E07C8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940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A903B7-463E-01D3-6CC1-0FE1EA032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590" y="2882295"/>
            <a:ext cx="10515600" cy="1325563"/>
          </a:xfrm>
        </p:spPr>
        <p:txBody>
          <a:bodyPr/>
          <a:lstStyle/>
          <a:p>
            <a:r>
              <a:rPr kumimoji="1" lang="en-US" altLang="ja-JP" dirty="0"/>
              <a:t>Supplementary material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68164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2C128DD-0732-29E7-7825-5617BBCB305A}"/>
              </a:ext>
            </a:extLst>
          </p:cNvPr>
          <p:cNvSpPr txBox="1"/>
          <p:nvPr/>
        </p:nvSpPr>
        <p:spPr>
          <a:xfrm>
            <a:off x="1982914" y="6006303"/>
            <a:ext cx="9084430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dirty="0">
                <a:latin typeface="Arial" panose="020B0604020202020204" pitchFamily="34" charset="0"/>
                <a:cs typeface="Arial" panose="020B0604020202020204" pitchFamily="34" charset="0"/>
              </a:rPr>
              <a:t>Figure S1.Survival outcomes according p16 status. (A) Progression free, (B) Overall survival.</a:t>
            </a:r>
            <a:endParaRPr lang="ja-JP" altLang="en-US" sz="18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90781BC5-FE7E-B112-78AE-F22C5C5AD932}"/>
              </a:ext>
            </a:extLst>
          </p:cNvPr>
          <p:cNvGrpSpPr/>
          <p:nvPr/>
        </p:nvGrpSpPr>
        <p:grpSpPr>
          <a:xfrm>
            <a:off x="1690571" y="1055024"/>
            <a:ext cx="8810856" cy="4680000"/>
            <a:chOff x="1010471" y="394305"/>
            <a:chExt cx="8810856" cy="4680000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1C5549DD-7B53-75C8-60D7-21056252F9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10471" y="394305"/>
              <a:ext cx="4680000" cy="4680000"/>
            </a:xfrm>
            <a:prstGeom prst="rect">
              <a:avLst/>
            </a:prstGeom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20C97BA0-3E5A-AB48-4BF4-A774E5AE4C79}"/>
                </a:ext>
              </a:extLst>
            </p:cNvPr>
            <p:cNvSpPr txBox="1"/>
            <p:nvPr/>
          </p:nvSpPr>
          <p:spPr>
            <a:xfrm>
              <a:off x="4595847" y="3702710"/>
              <a:ext cx="934871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1" dirty="0">
                  <a:latin typeface="Arial" panose="020B0604020202020204" pitchFamily="34" charset="0"/>
                  <a:cs typeface="Arial" panose="020B0604020202020204" pitchFamily="34" charset="0"/>
                </a:rPr>
                <a:t>p = 0.021</a:t>
              </a:r>
              <a:endParaRPr lang="ja-JP" altLang="en-US" sz="14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80D99E3D-4414-3DFD-AFFE-3F9FA94084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141327" y="394305"/>
              <a:ext cx="4680000" cy="4680000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D639773-1324-303C-C38A-3F741368DC9C}"/>
                </a:ext>
              </a:extLst>
            </p:cNvPr>
            <p:cNvSpPr txBox="1"/>
            <p:nvPr/>
          </p:nvSpPr>
          <p:spPr>
            <a:xfrm>
              <a:off x="8607750" y="3702710"/>
              <a:ext cx="934871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1" dirty="0">
                  <a:latin typeface="Arial" panose="020B0604020202020204" pitchFamily="34" charset="0"/>
                  <a:cs typeface="Arial" panose="020B0604020202020204" pitchFamily="34" charset="0"/>
                </a:rPr>
                <a:t>p = 0.043</a:t>
              </a:r>
              <a:endParaRPr lang="ja-JP" altLang="en-US" sz="14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251ECB1-377F-88AE-2AB0-86F67E8FA2CC}"/>
              </a:ext>
            </a:extLst>
          </p:cNvPr>
          <p:cNvSpPr txBox="1"/>
          <p:nvPr/>
        </p:nvSpPr>
        <p:spPr>
          <a:xfrm>
            <a:off x="2152044" y="1237839"/>
            <a:ext cx="110233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b="1" dirty="0"/>
              <a:t>A</a:t>
            </a:r>
            <a:endParaRPr lang="ja-JP" altLang="en-US" sz="1401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3F12F89-1C3E-AE56-5B63-F4A1B2C39A99}"/>
              </a:ext>
            </a:extLst>
          </p:cNvPr>
          <p:cNvSpPr txBox="1"/>
          <p:nvPr/>
        </p:nvSpPr>
        <p:spPr>
          <a:xfrm>
            <a:off x="6278441" y="1237840"/>
            <a:ext cx="511417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b="1" dirty="0"/>
              <a:t>B</a:t>
            </a:r>
            <a:endParaRPr lang="ja-JP" altLang="en-US" sz="1401" b="1" dirty="0"/>
          </a:p>
        </p:txBody>
      </p:sp>
    </p:spTree>
    <p:extLst>
      <p:ext uri="{BB962C8B-B14F-4D97-AF65-F5344CB8AC3E}">
        <p14:creationId xmlns:p14="http://schemas.microsoft.com/office/powerpoint/2010/main" val="3011964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DFDCD50-0F6A-A32C-4857-35D051D3F0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2914" y="1326301"/>
            <a:ext cx="4680000" cy="468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2A572888-5833-2F97-9F4C-B46CF5A6FC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0450" y="1326301"/>
            <a:ext cx="4680000" cy="4680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753C530-4C37-D2E7-02F2-640C0E25E9A3}"/>
              </a:ext>
            </a:extLst>
          </p:cNvPr>
          <p:cNvSpPr txBox="1"/>
          <p:nvPr/>
        </p:nvSpPr>
        <p:spPr>
          <a:xfrm>
            <a:off x="4182578" y="4505143"/>
            <a:ext cx="95244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1" dirty="0">
                <a:latin typeface="Arial" panose="020B0604020202020204" pitchFamily="34" charset="0"/>
                <a:cs typeface="Arial" panose="020B0604020202020204" pitchFamily="34" charset="0"/>
              </a:rPr>
              <a:t>P = 0.002</a:t>
            </a:r>
            <a:endParaRPr lang="ja-JP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082B255-368D-6EDF-04AD-EFFF7D8E4D60}"/>
              </a:ext>
            </a:extLst>
          </p:cNvPr>
          <p:cNvSpPr txBox="1"/>
          <p:nvPr/>
        </p:nvSpPr>
        <p:spPr>
          <a:xfrm>
            <a:off x="9361843" y="4505143"/>
            <a:ext cx="939103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1" dirty="0">
                <a:latin typeface="Arial" panose="020B0604020202020204" pitchFamily="34" charset="0"/>
                <a:cs typeface="Arial" panose="020B0604020202020204" pitchFamily="34" charset="0"/>
              </a:rPr>
              <a:t>P = 0.011</a:t>
            </a:r>
            <a:endParaRPr lang="ja-JP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F2A79A3-A22F-9B24-4DEA-6F3F793E4900}"/>
              </a:ext>
            </a:extLst>
          </p:cNvPr>
          <p:cNvSpPr txBox="1"/>
          <p:nvPr/>
        </p:nvSpPr>
        <p:spPr>
          <a:xfrm>
            <a:off x="1982914" y="6006303"/>
            <a:ext cx="9084430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18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1" dirty="0">
                <a:latin typeface="Arial" panose="020B0604020202020204" pitchFamily="34" charset="0"/>
                <a:cs typeface="Arial" panose="020B0604020202020204" pitchFamily="34" charset="0"/>
              </a:rPr>
              <a:t>S2.Survival outcomes of patients with IIB disease who underwent surgery. (A) Progression free survival in stage IIB, (B) Overall survival in stage IIB</a:t>
            </a:r>
            <a:endParaRPr lang="ja-JP" altLang="en-US" sz="18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94471B4-60E0-E218-C6C0-0A36446DCE92}"/>
              </a:ext>
            </a:extLst>
          </p:cNvPr>
          <p:cNvSpPr txBox="1"/>
          <p:nvPr/>
        </p:nvSpPr>
        <p:spPr>
          <a:xfrm>
            <a:off x="2494832" y="1591817"/>
            <a:ext cx="110233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b="1" dirty="0"/>
              <a:t>A</a:t>
            </a:r>
            <a:endParaRPr lang="ja-JP" altLang="en-US" sz="1401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B91A066-6C79-26F0-E7B7-E7D0CA6A48F2}"/>
              </a:ext>
            </a:extLst>
          </p:cNvPr>
          <p:cNvSpPr txBox="1"/>
          <p:nvPr/>
        </p:nvSpPr>
        <p:spPr>
          <a:xfrm>
            <a:off x="6662914" y="1591816"/>
            <a:ext cx="511417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b="1" dirty="0"/>
              <a:t>B</a:t>
            </a:r>
            <a:endParaRPr lang="ja-JP" altLang="en-US" sz="1401" b="1" dirty="0"/>
          </a:p>
        </p:txBody>
      </p:sp>
    </p:spTree>
    <p:extLst>
      <p:ext uri="{BB962C8B-B14F-4D97-AF65-F5344CB8AC3E}">
        <p14:creationId xmlns:p14="http://schemas.microsoft.com/office/powerpoint/2010/main" val="3985704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03FD23D4-11D9-5F93-00BD-7DA3B79C22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6292300"/>
              </p:ext>
            </p:extLst>
          </p:nvPr>
        </p:nvGraphicFramePr>
        <p:xfrm>
          <a:off x="1555617" y="1427138"/>
          <a:ext cx="9080766" cy="2857500"/>
        </p:xfrm>
        <a:graphic>
          <a:graphicData uri="http://schemas.openxmlformats.org/drawingml/2006/table">
            <a:tbl>
              <a:tblPr/>
              <a:tblGrid>
                <a:gridCol w="1955112">
                  <a:extLst>
                    <a:ext uri="{9D8B030D-6E8A-4147-A177-3AD203B41FA5}">
                      <a16:colId xmlns:a16="http://schemas.microsoft.com/office/drawing/2014/main" val="3221348279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4070100914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280865217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3803238281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1097520573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2757557990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1476205953"/>
                    </a:ext>
                  </a:extLst>
                </a:gridCol>
                <a:gridCol w="145422">
                  <a:extLst>
                    <a:ext uri="{9D8B030D-6E8A-4147-A177-3AD203B41FA5}">
                      <a16:colId xmlns:a16="http://schemas.microsoft.com/office/drawing/2014/main" val="3072790306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3117894734"/>
                    </a:ext>
                  </a:extLst>
                </a:gridCol>
                <a:gridCol w="872529">
                  <a:extLst>
                    <a:ext uri="{9D8B030D-6E8A-4147-A177-3AD203B41FA5}">
                      <a16:colId xmlns:a16="http://schemas.microsoft.com/office/drawing/2014/main" val="2152806866"/>
                    </a:ext>
                  </a:extLst>
                </a:gridCol>
              </a:tblGrid>
              <a:tr h="381000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haracteristic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PVa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group</a:t>
                      </a:r>
                      <a:endParaRPr lang="ja-JP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PVi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group</a:t>
                      </a:r>
                      <a:endParaRPr lang="ja-JP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Univari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ultivari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6473766"/>
                  </a:ext>
                </a:extLst>
              </a:tr>
              <a:tr h="2476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 = 103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 = 4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dds ratio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5%C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β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8815979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ge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≤ 5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2 (60.2)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 (33.3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563404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 5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1 (39.8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2 (66.7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470-6.2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1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0671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1701668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Lymphadenopathy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5 (82.5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5 (72.9)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6496199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 (17.5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 (27.1)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77-3.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227586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rametrium invasion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3 (72.3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2 (45.8)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9663540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+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8 (27.7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6 (54.2)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48-6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2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6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5545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8174535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umor diameter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&gt; 40 mm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8 (17.4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6 (33.3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4647946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≤ 40 mm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1 (78.6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0 (62.5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4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89-0.9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3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-0.115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2140798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Unknown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4 (3.9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 (4.2) 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322471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0DEB684-CDD6-4368-91D0-6DBCFFFB8724}"/>
              </a:ext>
            </a:extLst>
          </p:cNvPr>
          <p:cNvSpPr txBox="1"/>
          <p:nvPr/>
        </p:nvSpPr>
        <p:spPr>
          <a:xfrm>
            <a:off x="1555617" y="4441558"/>
            <a:ext cx="8232962" cy="5234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S1. Logistic regression</a:t>
            </a:r>
            <a:r>
              <a:rPr lang="ja-JP" altLang="en-US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</a:t>
            </a:r>
            <a:r>
              <a:rPr lang="ja-JP" altLang="en-US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ultiple</a:t>
            </a:r>
            <a:r>
              <a:rPr lang="ja-JP" altLang="en-US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gression</a:t>
            </a:r>
            <a:r>
              <a:rPr lang="ja-JP" altLang="en-US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alysis</a:t>
            </a:r>
            <a:r>
              <a:rPr lang="ja-JP" altLang="en-US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 identify significant </a:t>
            </a:r>
            <a:r>
              <a:rPr lang="en-US" altLang="ja-JP" sz="140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linico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pathological factors that differentiate </a:t>
            </a:r>
            <a:r>
              <a:rPr lang="en-US" altLang="ja-JP" sz="140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Va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d </a:t>
            </a:r>
            <a:r>
              <a:rPr lang="en-US" altLang="ja-JP" sz="140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Vi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ype.</a:t>
            </a:r>
            <a:endParaRPr lang="ja-JP" altLang="en-US" sz="1401" dirty="0"/>
          </a:p>
        </p:txBody>
      </p:sp>
    </p:spTree>
    <p:extLst>
      <p:ext uri="{BB962C8B-B14F-4D97-AF65-F5344CB8AC3E}">
        <p14:creationId xmlns:p14="http://schemas.microsoft.com/office/powerpoint/2010/main" val="7174178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15F4000-751F-4355-FEB6-83AD20BE2831}"/>
              </a:ext>
            </a:extLst>
          </p:cNvPr>
          <p:cNvSpPr txBox="1"/>
          <p:nvPr/>
        </p:nvSpPr>
        <p:spPr>
          <a:xfrm>
            <a:off x="5668567" y="4091982"/>
            <a:ext cx="5654105" cy="13857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S2. Chemotherapeutic regimen used for treatment. CDDP, cisplatin; PTX, paclitaxel; CBDCA, </a:t>
            </a:r>
            <a:r>
              <a:rPr lang="en-US" altLang="ja-JP" sz="140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arboplatin;NDP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nedaplatin; DTX, docetaxel; CPT, irinotecan, 5-FU, 5-fluorouracil; </a:t>
            </a:r>
            <a:r>
              <a:rPr lang="en-US" altLang="ja-JP" sz="140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.a.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intra-arterial infusion; NAC, neoadjuvant chemotherapy; CT, chemotherapy ; CCRT, concurrent chemoradiotherapy</a:t>
            </a:r>
            <a:r>
              <a:rPr lang="ja-JP" altLang="en-US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；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* Including radiotherapy + concurrent and subsequent chemotherapy</a:t>
            </a:r>
            <a:endParaRPr lang="ja-JP" altLang="en-US" sz="1401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2634E89-CBDA-3E7C-E712-8E1C1F72DA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7883166"/>
              </p:ext>
            </p:extLst>
          </p:nvPr>
        </p:nvGraphicFramePr>
        <p:xfrm>
          <a:off x="534646" y="409575"/>
          <a:ext cx="4608854" cy="5455571"/>
        </p:xfrm>
        <a:graphic>
          <a:graphicData uri="http://schemas.openxmlformats.org/drawingml/2006/table">
            <a:tbl>
              <a:tblPr/>
              <a:tblGrid>
                <a:gridCol w="991023">
                  <a:extLst>
                    <a:ext uri="{9D8B030D-6E8A-4147-A177-3AD203B41FA5}">
                      <a16:colId xmlns:a16="http://schemas.microsoft.com/office/drawing/2014/main" val="1127032196"/>
                    </a:ext>
                  </a:extLst>
                </a:gridCol>
                <a:gridCol w="991023">
                  <a:extLst>
                    <a:ext uri="{9D8B030D-6E8A-4147-A177-3AD203B41FA5}">
                      <a16:colId xmlns:a16="http://schemas.microsoft.com/office/drawing/2014/main" val="1277660252"/>
                    </a:ext>
                  </a:extLst>
                </a:gridCol>
                <a:gridCol w="991023">
                  <a:extLst>
                    <a:ext uri="{9D8B030D-6E8A-4147-A177-3AD203B41FA5}">
                      <a16:colId xmlns:a16="http://schemas.microsoft.com/office/drawing/2014/main" val="2577618006"/>
                    </a:ext>
                  </a:extLst>
                </a:gridCol>
                <a:gridCol w="991023">
                  <a:extLst>
                    <a:ext uri="{9D8B030D-6E8A-4147-A177-3AD203B41FA5}">
                      <a16:colId xmlns:a16="http://schemas.microsoft.com/office/drawing/2014/main" val="211983012"/>
                    </a:ext>
                  </a:extLst>
                </a:gridCol>
                <a:gridCol w="644762">
                  <a:extLst>
                    <a:ext uri="{9D8B030D-6E8A-4147-A177-3AD203B41FA5}">
                      <a16:colId xmlns:a16="http://schemas.microsoft.com/office/drawing/2014/main" val="2951680509"/>
                    </a:ext>
                  </a:extLst>
                </a:gridCol>
              </a:tblGrid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gimens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PV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PVi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1249592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AC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X/CBDC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6126049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X/CD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339217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TX/CBDC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4458730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PT-11/N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2513346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DP i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3303577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4054443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1329686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djuvant CT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X/CBDC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066068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X/CD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9553419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TX/CBDC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569624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PT-11/N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4124431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PT-11/ CD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2163655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PT-1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7595375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1647174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7093311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CRT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63934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6950777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6351600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0775238"/>
                  </a:ext>
                </a:extLst>
              </a:tr>
              <a:tr h="32735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djuvant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CRT*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DP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5749666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BDCA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2411596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ED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8284662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thers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6390448"/>
                  </a:ext>
                </a:extLst>
              </a:tr>
              <a:tr h="166867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5</a:t>
                      </a:r>
                    </a:p>
                  </a:txBody>
                  <a:tcPr marL="6362" marR="6362" marT="63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84050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904177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FC3E781-15B4-18F4-A28F-34347C37AEE7}"/>
              </a:ext>
            </a:extLst>
          </p:cNvPr>
          <p:cNvSpPr txBox="1"/>
          <p:nvPr/>
        </p:nvSpPr>
        <p:spPr>
          <a:xfrm>
            <a:off x="434975" y="4572001"/>
            <a:ext cx="11639550" cy="739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kern="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able S3. Detailed pathological information. </a:t>
            </a:r>
            <a:r>
              <a:rPr lang="en-US" altLang="ja-JP" sz="1401" kern="50" dirty="0" err="1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PVa</a:t>
            </a:r>
            <a:r>
              <a:rPr lang="en-US" altLang="ja-JP" sz="1401" kern="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HPV associated; </a:t>
            </a:r>
            <a:r>
              <a:rPr lang="en-US" altLang="ja-JP" sz="1401" kern="50" dirty="0" err="1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PVi</a:t>
            </a:r>
            <a:r>
              <a:rPr lang="en-US" altLang="ja-JP" sz="1401" kern="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HPV independent; UEA; usual-type adenocarcinoma; MUC NOS, mucinous carcinoma, not otherwise specified; </a:t>
            </a:r>
            <a:r>
              <a:rPr lang="en-US" altLang="ja-JP" sz="1401" dirty="0" err="1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denocaricinoma</a:t>
            </a:r>
            <a:r>
              <a:rPr lang="en-US" altLang="ja-JP" sz="1401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NOS</a:t>
            </a:r>
            <a:r>
              <a:rPr lang="en-US" altLang="ja-JP" sz="1401" kern="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adenocarcinoma not otherwise specified; GAS, gastric-type adenocarcinoma; CCC, clear cell carcinoma</a:t>
            </a:r>
            <a:endParaRPr lang="ja-JP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F91F959-32C7-299F-23FD-AD354F25C7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9738133"/>
              </p:ext>
            </p:extLst>
          </p:nvPr>
        </p:nvGraphicFramePr>
        <p:xfrm>
          <a:off x="717884" y="1546951"/>
          <a:ext cx="10515601" cy="2389344"/>
        </p:xfrm>
        <a:graphic>
          <a:graphicData uri="http://schemas.openxmlformats.org/drawingml/2006/table">
            <a:tbl>
              <a:tblPr/>
              <a:tblGrid>
                <a:gridCol w="634669">
                  <a:extLst>
                    <a:ext uri="{9D8B030D-6E8A-4147-A177-3AD203B41FA5}">
                      <a16:colId xmlns:a16="http://schemas.microsoft.com/office/drawing/2014/main" val="2777103872"/>
                    </a:ext>
                  </a:extLst>
                </a:gridCol>
                <a:gridCol w="2128009">
                  <a:extLst>
                    <a:ext uri="{9D8B030D-6E8A-4147-A177-3AD203B41FA5}">
                      <a16:colId xmlns:a16="http://schemas.microsoft.com/office/drawing/2014/main" val="47683355"/>
                    </a:ext>
                  </a:extLst>
                </a:gridCol>
                <a:gridCol w="472891">
                  <a:extLst>
                    <a:ext uri="{9D8B030D-6E8A-4147-A177-3AD203B41FA5}">
                      <a16:colId xmlns:a16="http://schemas.microsoft.com/office/drawing/2014/main" val="1809048699"/>
                    </a:ext>
                  </a:extLst>
                </a:gridCol>
                <a:gridCol w="1194672">
                  <a:extLst>
                    <a:ext uri="{9D8B030D-6E8A-4147-A177-3AD203B41FA5}">
                      <a16:colId xmlns:a16="http://schemas.microsoft.com/office/drawing/2014/main" val="2046542245"/>
                    </a:ext>
                  </a:extLst>
                </a:gridCol>
                <a:gridCol w="1194672">
                  <a:extLst>
                    <a:ext uri="{9D8B030D-6E8A-4147-A177-3AD203B41FA5}">
                      <a16:colId xmlns:a16="http://schemas.microsoft.com/office/drawing/2014/main" val="190729542"/>
                    </a:ext>
                  </a:extLst>
                </a:gridCol>
                <a:gridCol w="1194672">
                  <a:extLst>
                    <a:ext uri="{9D8B030D-6E8A-4147-A177-3AD203B41FA5}">
                      <a16:colId xmlns:a16="http://schemas.microsoft.com/office/drawing/2014/main" val="2946484165"/>
                    </a:ext>
                  </a:extLst>
                </a:gridCol>
                <a:gridCol w="112000">
                  <a:extLst>
                    <a:ext uri="{9D8B030D-6E8A-4147-A177-3AD203B41FA5}">
                      <a16:colId xmlns:a16="http://schemas.microsoft.com/office/drawing/2014/main" val="2463593422"/>
                    </a:ext>
                  </a:extLst>
                </a:gridCol>
                <a:gridCol w="1194672">
                  <a:extLst>
                    <a:ext uri="{9D8B030D-6E8A-4147-A177-3AD203B41FA5}">
                      <a16:colId xmlns:a16="http://schemas.microsoft.com/office/drawing/2014/main" val="3916579618"/>
                    </a:ext>
                  </a:extLst>
                </a:gridCol>
                <a:gridCol w="1194672">
                  <a:extLst>
                    <a:ext uri="{9D8B030D-6E8A-4147-A177-3AD203B41FA5}">
                      <a16:colId xmlns:a16="http://schemas.microsoft.com/office/drawing/2014/main" val="1403097716"/>
                    </a:ext>
                  </a:extLst>
                </a:gridCol>
                <a:gridCol w="1194672">
                  <a:extLst>
                    <a:ext uri="{9D8B030D-6E8A-4147-A177-3AD203B41FA5}">
                      <a16:colId xmlns:a16="http://schemas.microsoft.com/office/drawing/2014/main" val="1254065401"/>
                    </a:ext>
                  </a:extLst>
                </a:gridCol>
              </a:tblGrid>
              <a:tr h="29866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16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53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7661860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ubtype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sitive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egative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rmal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bberent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Unknown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0031933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PVa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UEA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7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0 (69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 (3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1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2 (94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 (6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9748643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ucinous NOS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 (8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 (2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 (93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7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6610379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denocaricinoma NOS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10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10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3492775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PVi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S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3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 (16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6 (84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3 (53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 (44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2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5902644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CC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25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 (75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 (10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 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969609"/>
                  </a:ext>
                </a:extLst>
              </a:tr>
              <a:tr h="298668">
                <a:tc>
                  <a:txBody>
                    <a:bodyPr/>
                    <a:lstStyle/>
                    <a:p>
                      <a:pPr algn="l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dometrioid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10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 (10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 (0%)</a:t>
                      </a:r>
                    </a:p>
                  </a:txBody>
                  <a:tcPr marL="9333" marR="9333" marT="9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54399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1227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1CAE2605-D322-3285-645B-87B03175AE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152" y="1967922"/>
            <a:ext cx="184731" cy="369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1" rIns="91440" bIns="45721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801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52184A9-2EE4-1F16-BF6E-ADA95D971FF1}"/>
              </a:ext>
            </a:extLst>
          </p:cNvPr>
          <p:cNvSpPr txBox="1"/>
          <p:nvPr/>
        </p:nvSpPr>
        <p:spPr>
          <a:xfrm>
            <a:off x="695322" y="3744257"/>
            <a:ext cx="10729669" cy="954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 S4. Cases with  </a:t>
            </a:r>
            <a:r>
              <a:rPr lang="en-US" altLang="ja-JP" sz="140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Vi</a:t>
            </a:r>
            <a:r>
              <a:rPr lang="en-US" altLang="ja-JP" sz="140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GAS) treated with definitive radiotherapy with or without concurrent chemotherapy. PTX/CDDP; paclitaxel/cisplatin, NDP; nedaplatin, CR; complete response, PR; partial response, NED: no evidence of disease, DOD; died of disease,, NA; not available</a:t>
            </a:r>
            <a:endParaRPr lang="ja-JP" altLang="ja-JP" sz="1401" kern="100" dirty="0"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lang="ja-JP" altLang="en-US" sz="1401" dirty="0"/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A6295AE6-6DD6-B9FA-5AB3-2A2A9A3D6D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2297579"/>
              </p:ext>
            </p:extLst>
          </p:nvPr>
        </p:nvGraphicFramePr>
        <p:xfrm>
          <a:off x="802356" y="999561"/>
          <a:ext cx="10515603" cy="2744696"/>
        </p:xfrm>
        <a:graphic>
          <a:graphicData uri="http://schemas.openxmlformats.org/drawingml/2006/table">
            <a:tbl>
              <a:tblPr/>
              <a:tblGrid>
                <a:gridCol w="599148">
                  <a:extLst>
                    <a:ext uri="{9D8B030D-6E8A-4147-A177-3AD203B41FA5}">
                      <a16:colId xmlns:a16="http://schemas.microsoft.com/office/drawing/2014/main" val="752864132"/>
                    </a:ext>
                  </a:extLst>
                </a:gridCol>
                <a:gridCol w="454908">
                  <a:extLst>
                    <a:ext uri="{9D8B030D-6E8A-4147-A177-3AD203B41FA5}">
                      <a16:colId xmlns:a16="http://schemas.microsoft.com/office/drawing/2014/main" val="654436834"/>
                    </a:ext>
                  </a:extLst>
                </a:gridCol>
                <a:gridCol w="454908">
                  <a:extLst>
                    <a:ext uri="{9D8B030D-6E8A-4147-A177-3AD203B41FA5}">
                      <a16:colId xmlns:a16="http://schemas.microsoft.com/office/drawing/2014/main" val="1517417021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1365652168"/>
                    </a:ext>
                  </a:extLst>
                </a:gridCol>
                <a:gridCol w="854341">
                  <a:extLst>
                    <a:ext uri="{9D8B030D-6E8A-4147-A177-3AD203B41FA5}">
                      <a16:colId xmlns:a16="http://schemas.microsoft.com/office/drawing/2014/main" val="280485227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4072284691"/>
                    </a:ext>
                  </a:extLst>
                </a:gridCol>
                <a:gridCol w="854341">
                  <a:extLst>
                    <a:ext uri="{9D8B030D-6E8A-4147-A177-3AD203B41FA5}">
                      <a16:colId xmlns:a16="http://schemas.microsoft.com/office/drawing/2014/main" val="2008344706"/>
                    </a:ext>
                  </a:extLst>
                </a:gridCol>
                <a:gridCol w="857115">
                  <a:extLst>
                    <a:ext uri="{9D8B030D-6E8A-4147-A177-3AD203B41FA5}">
                      <a16:colId xmlns:a16="http://schemas.microsoft.com/office/drawing/2014/main" val="3997094595"/>
                    </a:ext>
                  </a:extLst>
                </a:gridCol>
                <a:gridCol w="823829">
                  <a:extLst>
                    <a:ext uri="{9D8B030D-6E8A-4147-A177-3AD203B41FA5}">
                      <a16:colId xmlns:a16="http://schemas.microsoft.com/office/drawing/2014/main" val="3212830991"/>
                    </a:ext>
                  </a:extLst>
                </a:gridCol>
                <a:gridCol w="823829">
                  <a:extLst>
                    <a:ext uri="{9D8B030D-6E8A-4147-A177-3AD203B41FA5}">
                      <a16:colId xmlns:a16="http://schemas.microsoft.com/office/drawing/2014/main" val="3507018625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93421705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616197272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386951654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1213180602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2752909122"/>
                    </a:ext>
                  </a:extLst>
                </a:gridCol>
                <a:gridCol w="599148">
                  <a:extLst>
                    <a:ext uri="{9D8B030D-6E8A-4147-A177-3AD203B41FA5}">
                      <a16:colId xmlns:a16="http://schemas.microsoft.com/office/drawing/2014/main" val="169585371"/>
                    </a:ext>
                  </a:extLst>
                </a:gridCol>
              </a:tblGrid>
              <a:tr h="22203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g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tag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umor diameter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ubtyp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16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bnormal p53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hemotherapy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rradiation dos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reatment Respons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laps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F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te of relapse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ognosi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5520715"/>
                  </a:ext>
                </a:extLst>
              </a:tr>
              <a:tr h="22203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days)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days)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3190309"/>
                  </a:ext>
                </a:extLst>
              </a:tr>
              <a:tr h="33749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mm)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ternal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ntracavitary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7339263"/>
                  </a:ext>
                </a:extLst>
              </a:tr>
              <a:tr h="27981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Gy)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Gy)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3107389"/>
                  </a:ext>
                </a:extLst>
              </a:tr>
              <a:tr h="2575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9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B3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0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0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277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277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ED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9385188"/>
                  </a:ext>
                </a:extLst>
              </a:tr>
              <a:tr h="27981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6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IA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0.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97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ung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09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ED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6233302"/>
                  </a:ext>
                </a:extLst>
              </a:tr>
              <a:tr h="27981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8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IB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5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R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91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ung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41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OD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2916352"/>
                  </a:ext>
                </a:extLst>
              </a:tr>
              <a:tr h="2575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3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IB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A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DP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0.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52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652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ied of other </a:t>
                      </a:r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isea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6621454"/>
                  </a:ext>
                </a:extLst>
              </a:tr>
              <a:tr h="3340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IIC1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0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AS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X/CDDP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0.4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8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Uterus, ischium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77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OD</a:t>
                      </a:r>
                    </a:p>
                  </a:txBody>
                  <a:tcPr marL="8882" marR="8882" marT="8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00753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8246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71</TotalTime>
  <Words>852</Words>
  <Application>Microsoft Office PowerPoint</Application>
  <PresentationFormat>ワイド画面</PresentationFormat>
  <Paragraphs>373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游明朝</vt:lpstr>
      <vt:lpstr>Arial</vt:lpstr>
      <vt:lpstr>Office テーマ</vt:lpstr>
      <vt:lpstr>Supplementary materials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GSG015　2022/10/13</dc:title>
  <dc:creator>関 寿之</dc:creator>
  <cp:lastModifiedBy>関 寿之</cp:lastModifiedBy>
  <cp:revision>54</cp:revision>
  <dcterms:created xsi:type="dcterms:W3CDTF">2022-10-13T06:56:23Z</dcterms:created>
  <dcterms:modified xsi:type="dcterms:W3CDTF">2023-03-01T13:36:17Z</dcterms:modified>
</cp:coreProperties>
</file>